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907588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FCE576-D2F4-4EA0-AC6B-E6F1E9DD967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F3F75E-38C2-4A85-85A8-D70D0FF8B91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1E4193-175A-4859-BFCF-A10A2362EEB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964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2428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500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964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2428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43D9DA-6360-4487-90B1-D1DECCB57FB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814995-DB5C-4598-B75D-1DCE72ED432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9EC792-19B0-4EDE-B2ED-1CAA5F3F2F1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0676F7-2E52-4072-AAA0-0C85917801C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5622A8-1E72-4487-980D-20F7247EEFB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5000" y="274320"/>
            <a:ext cx="8915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243E5A-C219-4295-9C16-9ED65E2EC01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967A28-673D-4C0D-A6AE-AB168E8519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EBDC35-1721-481E-8874-3F5947A721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241472-6F4F-4A8A-8E9A-42A9B446F6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5360" y="6244920"/>
            <a:ext cx="231120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384360" y="6244920"/>
            <a:ext cx="313668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098840" y="6244920"/>
            <a:ext cx="231156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NZ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D90F7E9-C3D9-4BD2-B528-B8FA6185EB9D}" type="slidenum">
              <a:rPr b="0" lang="en-NZ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hyperlink" Target="http://www.ncbi.nlm.nih.gov/entrez/query.fcgi?submit=y&amp;db=Nucleotide&amp;term=FG499166" TargetMode="External"/><Relationship Id="rId2" Type="http://schemas.openxmlformats.org/officeDocument/2006/relationships/hyperlink" Target="http://www.ncbi.nlm.nih.gov/entrez/query.fcgi?submit=y&amp;db=Nucleotide&amp;term=FG482624" TargetMode="External"/><Relationship Id="rId3" Type="http://schemas.openxmlformats.org/officeDocument/2006/relationships/hyperlink" Target="http://www.ncbi.nlm.nih.gov/entrez/query.fcgi?submit=y&amp;db=Nucleotide&amp;term=FG527942" TargetMode="External"/><Relationship Id="rId4" Type="http://schemas.openxmlformats.org/officeDocument/2006/relationships/hyperlink" Target="http://www.ncbi.nlm.nih.gov/entrez/query.fcgi?submit=y&amp;db=Nucleotide&amp;term=FG439911" TargetMode="External"/><Relationship Id="rId5" Type="http://schemas.openxmlformats.org/officeDocument/2006/relationships/hyperlink" Target="http://www.ncbi.nlm.nih.gov/entrez/query.fcgi?submit=y&amp;db=Nucleotide&amp;term=FG486019" TargetMode="External"/><Relationship Id="rId6" Type="http://schemas.openxmlformats.org/officeDocument/2006/relationships/hyperlink" Target="http://www.ncbi.nlm.nih.gov/entrez/query.fcgi?submit=y&amp;db=Nucleotide&amp;term=FG525163" TargetMode="External"/><Relationship Id="rId7" Type="http://schemas.openxmlformats.org/officeDocument/2006/relationships/hyperlink" Target="http://www.ncbi.nlm.nih.gov/entrez/query.fcgi?submit=y&amp;db=Nucleotide&amp;term=FG460077" TargetMode="External"/><Relationship Id="rId8" Type="http://schemas.openxmlformats.org/officeDocument/2006/relationships/hyperlink" Target="http://www.ncbi.nlm.nih.gov/entrez/query.fcgi?submit=y&amp;db=Nucleotide&amp;term=FG460245" TargetMode="External"/><Relationship Id="rId9" Type="http://schemas.openxmlformats.org/officeDocument/2006/relationships/hyperlink" Target="http://www.ncbi.nlm.nih.gov/entrez/query.fcgi?submit=y&amp;db=Nucleotide&amp;term=FG508207" TargetMode="External"/><Relationship Id="rId10" Type="http://schemas.openxmlformats.org/officeDocument/2006/relationships/hyperlink" Target="http://www.ncbi.nlm.nih.gov/entrez/query.fcgi?submit=y&amp;db=Nucleotide&amp;term=FG527135" TargetMode="External"/><Relationship Id="rId11" Type="http://schemas.openxmlformats.org/officeDocument/2006/relationships/hyperlink" Target="http://www.ncbi.nlm.nih.gov/entrez/query.fcgi?submit=y&amp;db=Nucleotide&amp;term=FG499166" TargetMode="External"/><Relationship Id="rId12" Type="http://schemas.openxmlformats.org/officeDocument/2006/relationships/hyperlink" Target="http://www.ncbi.nlm.nih.gov/entrez/query.fcgi?submit=y&amp;db=Nucleotide&amp;term=FG473391" TargetMode="External"/><Relationship Id="rId13" Type="http://schemas.openxmlformats.org/officeDocument/2006/relationships/hyperlink" Target="http://www.ncbi.nlm.nih.gov/entrez/query.fcgi?submit=y&amp;db=Nucleotide&amp;term=FG437743" TargetMode="External"/><Relationship Id="rId1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560520" y="404640"/>
          <a:ext cx="8432640" cy="5270760"/>
        </p:xfrm>
        <a:graphic>
          <a:graphicData uri="http://schemas.openxmlformats.org/drawingml/2006/table">
            <a:tbl>
              <a:tblPr/>
              <a:tblGrid>
                <a:gridCol w="936360"/>
                <a:gridCol w="1911600"/>
                <a:gridCol w="936360"/>
                <a:gridCol w="2360880"/>
                <a:gridCol w="2287440"/>
              </a:tblGrid>
              <a:tr h="246240"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NZ" sz="12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descrip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NZ" sz="12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GB I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NZ" sz="12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Forward Prime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bbe0e3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NZ" sz="12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Reverse Prime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bbe0e3"/>
                    </a:solidFill>
                  </a:tcPr>
                </a:tc>
              </a:tr>
              <a:tr h="254160"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ontrol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F1a - qPCR control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CACTGTCATTGATGCTCC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CAGCTTCAAAACCACCAG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</a:tr>
              <a:tr h="252360"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ontrol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P2a- qPCR control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CAGCACATAATTCCACAG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TTCTGAGCCCATAACAGGA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</a:tr>
              <a:tr h="253800"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lpha expansin  7 (EXP7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 u="sng">
                          <a:solidFill>
                            <a:srgbClr val="009999"/>
                          </a:solidFill>
                          <a:uFillTx/>
                          <a:latin typeface="Arial"/>
                          <a:hlinkClick r:id="rId1"/>
                        </a:rPr>
                        <a:t>FG4991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CATGCACATTAGAGAGGCAAGC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TCCTCTCAATGGCCCACCAA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</a:tr>
              <a:tr h="252360"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uxin response factor (ARF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 u="sng">
                          <a:solidFill>
                            <a:srgbClr val="009999"/>
                          </a:solidFill>
                          <a:uFillTx/>
                          <a:latin typeface="Arial"/>
                          <a:hlinkClick r:id="rId2"/>
                        </a:rPr>
                        <a:t>FG48262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ATGAAGTAGAGGTTTCGC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CTTCTCCACATCCTTCAT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</a:tr>
              <a:tr h="338400"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lorophyll a-b binding protein P2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 u="sng">
                          <a:solidFill>
                            <a:srgbClr val="009999"/>
                          </a:solidFill>
                          <a:uFillTx/>
                          <a:latin typeface="Arial"/>
                          <a:hlinkClick r:id="rId3"/>
                        </a:rPr>
                        <a:t>FG527942</a:t>
                      </a: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TGTCAGGACCGTACCACTTG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AGCCCGTCGCTCTCTTCT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</a:tr>
              <a:tr h="269640"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ucrose Synthase (SUSA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 u="sng">
                          <a:solidFill>
                            <a:srgbClr val="009999"/>
                          </a:solidFill>
                          <a:uFillTx/>
                          <a:latin typeface="Arial"/>
                          <a:hlinkClick r:id="rId4"/>
                        </a:rPr>
                        <a:t>FG4399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TGCCGAATTACAGGGTGT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AGCAATGGTGCACTGTGT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</a:tr>
              <a:tr h="252360"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ycopene Beta cycla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 u="sng">
                          <a:solidFill>
                            <a:srgbClr val="009999"/>
                          </a:solidFill>
                          <a:uFillTx/>
                          <a:latin typeface="Arial"/>
                          <a:hlinkClick r:id="rId5"/>
                        </a:rPr>
                        <a:t>FG486019</a:t>
                      </a: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TGGCATGGAGACTTTGTTGAAG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CTTGAAGAGAGAAACCCTTGCC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</a:tr>
              <a:tr h="254160"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β</a:t>
                      </a: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Amyla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 u="sng">
                          <a:solidFill>
                            <a:srgbClr val="009999"/>
                          </a:solidFill>
                          <a:uFillTx/>
                          <a:latin typeface="Arial"/>
                          <a:hlinkClick r:id="rId6"/>
                        </a:rPr>
                        <a:t>FG52516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CCTGACCTTGTCTACAC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GGGTGTTCTTCCTCTAA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</a:tr>
              <a:tr h="252360"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PALLATA 4 (SEP4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 u="sng">
                          <a:solidFill>
                            <a:srgbClr val="009999"/>
                          </a:solidFill>
                          <a:uFillTx/>
                          <a:latin typeface="Arial"/>
                          <a:hlinkClick r:id="rId7"/>
                        </a:rPr>
                        <a:t>FG460077</a:t>
                      </a: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GCTAGCTGAGTCCAACAA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CGGACTGGGCAGGAACGTGA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</a:tr>
              <a:tr h="254160"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CC oxidase (ACO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 u="sng">
                          <a:solidFill>
                            <a:srgbClr val="009999"/>
                          </a:solidFill>
                          <a:uFillTx/>
                          <a:latin typeface="Arial"/>
                          <a:hlinkClick r:id="rId8"/>
                        </a:rPr>
                        <a:t>FG460245</a:t>
                      </a: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GTGTTTGTGTGAACTTAG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CAACACACCAGCCAAGCA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</a:tr>
              <a:tr h="252360"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dditional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</a:tr>
              <a:tr h="253800"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l-GR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β</a:t>
                      </a: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galactosida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 u="sng">
                          <a:solidFill>
                            <a:srgbClr val="009999"/>
                          </a:solidFill>
                          <a:uFillTx/>
                          <a:latin typeface="Arial"/>
                          <a:hlinkClick r:id="rId9"/>
                        </a:rPr>
                        <a:t>FG508207</a:t>
                      </a: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AAGCATTGGGCGTTATTGG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CCACAATTCTTGAGGCATTT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</a:tr>
              <a:tr h="336600"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xygen-evolving enhancer protein (OEE1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 u="sng">
                          <a:solidFill>
                            <a:srgbClr val="009999"/>
                          </a:solidFill>
                          <a:uFillTx/>
                          <a:latin typeface="Arial"/>
                          <a:hlinkClick r:id="rId10"/>
                        </a:rPr>
                        <a:t>FG527135</a:t>
                      </a: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GGGTCCAAGAAAGACGAGC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CCCTTCCTCTTCACCATCAA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</a:tr>
              <a:tr h="254160"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ucrose phosphate syntha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 u="sng">
                          <a:solidFill>
                            <a:srgbClr val="009999"/>
                          </a:solidFill>
                          <a:uFillTx/>
                          <a:latin typeface="Arial"/>
                          <a:hlinkClick r:id="rId11"/>
                        </a:rPr>
                        <a:t>FG499166</a:t>
                      </a: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TGATTCGTTGGGCTGGTTCTAT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CTTTCCTGCGTTTCGCACT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</a:tr>
              <a:tr h="252360"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arch Synthase 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 u="sng">
                          <a:solidFill>
                            <a:srgbClr val="009999"/>
                          </a:solidFill>
                          <a:uFillTx/>
                          <a:latin typeface="Arial"/>
                          <a:hlinkClick r:id="rId12"/>
                        </a:rPr>
                        <a:t>FG47339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GGTTAATGAAGAGAGGAA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ATAGGGAGAGTCGATGAA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</a:tr>
              <a:tr h="338040"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ed maturation protein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(LEA D-34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 u="sng">
                          <a:solidFill>
                            <a:srgbClr val="009999"/>
                          </a:solidFill>
                          <a:uFillTx/>
                          <a:latin typeface="Arial"/>
                          <a:hlinkClick r:id="rId13"/>
                        </a:rPr>
                        <a:t>FG437743</a:t>
                      </a: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GGAGGATGCAAGTGCGAAG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GCCATTCTCGAATTGTTCCTC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</a:tr>
              <a:tr h="235080"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lpha expansin 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G525103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GGCCAGAACTGGCAGTCC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GATGTTCCAGGATGTGGAGG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</a:tr>
              <a:tr h="235080"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olygalacturonas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G50877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GCGACACAAGTTGCGATT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NZ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GCTGGTTGATTATTGTAG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f3f9fa"/>
                    </a:solidFill>
                  </a:tcPr>
                </a:tc>
              </a:tr>
              <a:tr h="233280"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  <a:tc>
                  <a:txBody>
                    <a:bodyPr lIns="132120" rIns="132120" tIns="31680" bIns="3168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132120" marR="1321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7f3f4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8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3-10T03:54:40Z</dcterms:created>
  <dc:creator>hrarjs</dc:creator>
  <dc:description/>
  <dc:language>en-US</dc:language>
  <cp:lastModifiedBy>hrarjs</cp:lastModifiedBy>
  <dcterms:modified xsi:type="dcterms:W3CDTF">2011-11-11T04:04:12Z</dcterms:modified>
  <cp:revision>136</cp:revision>
  <dc:subject/>
  <dc:title>Slide 1</dc:title>
</cp:coreProperties>
</file>